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8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160" userDrawn="1">
          <p15:clr>
            <a:srgbClr val="A4A3A4"/>
          </p15:clr>
        </p15:guide>
        <p15:guide id="3" orient="horz" pos="1436" userDrawn="1">
          <p15:clr>
            <a:srgbClr val="A4A3A4"/>
          </p15:clr>
        </p15:guide>
        <p15:guide id="4" orient="horz" pos="4407" userDrawn="1">
          <p15:clr>
            <a:srgbClr val="A4A3A4"/>
          </p15:clr>
        </p15:guide>
        <p15:guide id="5" orient="horz" pos="5677" userDrawn="1">
          <p15:clr>
            <a:srgbClr val="A4A3A4"/>
          </p15:clr>
        </p15:guide>
        <p15:guide id="6" pos="504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3568552-42BF-41B2-A50E-B7B6266727A2}" name="Mireille Vankemmelbeke" initials="MV" userId="S::MireilleVankemmelbeke@scancell.co.uk::e2496c92-8ae2-4817-81db-1e2fdf7923b3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25" d="100"/>
          <a:sy n="125" d="100"/>
        </p:scale>
        <p:origin x="1070" y="-110"/>
      </p:cViewPr>
      <p:guideLst>
        <p:guide orient="horz" pos="3840"/>
        <p:guide pos="2160"/>
        <p:guide orient="horz" pos="1436"/>
        <p:guide orient="horz" pos="4407"/>
        <p:guide orient="horz" pos="5677"/>
        <p:guide pos="50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8/10/relationships/authors" Target="author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ireille Vankemmelbeke" userId="e2496c92-8ae2-4817-81db-1e2fdf7923b3" providerId="ADAL" clId="{4B5540E2-12A2-4CC7-9B89-4E6756A3AA59}"/>
    <pc:docChg chg="custSel delSld modSld">
      <pc:chgData name="Mireille Vankemmelbeke" userId="e2496c92-8ae2-4817-81db-1e2fdf7923b3" providerId="ADAL" clId="{4B5540E2-12A2-4CC7-9B89-4E6756A3AA59}" dt="2024-06-21T15:36:55.472" v="5" actId="47"/>
      <pc:docMkLst>
        <pc:docMk/>
      </pc:docMkLst>
      <pc:sldChg chg="delSp modSp mod">
        <pc:chgData name="Mireille Vankemmelbeke" userId="e2496c92-8ae2-4817-81db-1e2fdf7923b3" providerId="ADAL" clId="{4B5540E2-12A2-4CC7-9B89-4E6756A3AA59}" dt="2024-06-21T15:36:50.045" v="3" actId="478"/>
        <pc:sldMkLst>
          <pc:docMk/>
          <pc:sldMk cId="3935331238" sldId="268"/>
        </pc:sldMkLst>
        <pc:spChg chg="del">
          <ac:chgData name="Mireille Vankemmelbeke" userId="e2496c92-8ae2-4817-81db-1e2fdf7923b3" providerId="ADAL" clId="{4B5540E2-12A2-4CC7-9B89-4E6756A3AA59}" dt="2024-06-21T15:36:41.952" v="1" actId="478"/>
          <ac:spMkLst>
            <pc:docMk/>
            <pc:sldMk cId="3935331238" sldId="268"/>
            <ac:spMk id="7" creationId="{79992CF2-F656-6E86-8F97-EAE850C1D6A1}"/>
          </ac:spMkLst>
        </pc:spChg>
        <pc:spChg chg="del">
          <ac:chgData name="Mireille Vankemmelbeke" userId="e2496c92-8ae2-4817-81db-1e2fdf7923b3" providerId="ADAL" clId="{4B5540E2-12A2-4CC7-9B89-4E6756A3AA59}" dt="2024-06-21T15:36:35.529" v="0" actId="478"/>
          <ac:spMkLst>
            <pc:docMk/>
            <pc:sldMk cId="3935331238" sldId="268"/>
            <ac:spMk id="8" creationId="{52FC7288-0277-B97D-DFD0-DDE8537FA61F}"/>
          </ac:spMkLst>
        </pc:spChg>
        <pc:spChg chg="mod">
          <ac:chgData name="Mireille Vankemmelbeke" userId="e2496c92-8ae2-4817-81db-1e2fdf7923b3" providerId="ADAL" clId="{4B5540E2-12A2-4CC7-9B89-4E6756A3AA59}" dt="2024-06-21T15:36:47.764" v="2" actId="1076"/>
          <ac:spMkLst>
            <pc:docMk/>
            <pc:sldMk cId="3935331238" sldId="268"/>
            <ac:spMk id="9" creationId="{329F8FB0-E780-D480-8A95-4E9518BEA6E8}"/>
          </ac:spMkLst>
        </pc:spChg>
        <pc:spChg chg="del">
          <ac:chgData name="Mireille Vankemmelbeke" userId="e2496c92-8ae2-4817-81db-1e2fdf7923b3" providerId="ADAL" clId="{4B5540E2-12A2-4CC7-9B89-4E6756A3AA59}" dt="2024-06-21T15:36:35.529" v="0" actId="478"/>
          <ac:spMkLst>
            <pc:docMk/>
            <pc:sldMk cId="3935331238" sldId="268"/>
            <ac:spMk id="11" creationId="{C837B6D7-0600-4F78-4369-7FBEBF40A86E}"/>
          </ac:spMkLst>
        </pc:spChg>
        <pc:spChg chg="del">
          <ac:chgData name="Mireille Vankemmelbeke" userId="e2496c92-8ae2-4817-81db-1e2fdf7923b3" providerId="ADAL" clId="{4B5540E2-12A2-4CC7-9B89-4E6756A3AA59}" dt="2024-06-21T15:36:35.529" v="0" actId="478"/>
          <ac:spMkLst>
            <pc:docMk/>
            <pc:sldMk cId="3935331238" sldId="268"/>
            <ac:spMk id="12" creationId="{C8E8BB72-0835-9E31-583F-D761EAD1BFAD}"/>
          </ac:spMkLst>
        </pc:spChg>
        <pc:spChg chg="del">
          <ac:chgData name="Mireille Vankemmelbeke" userId="e2496c92-8ae2-4817-81db-1e2fdf7923b3" providerId="ADAL" clId="{4B5540E2-12A2-4CC7-9B89-4E6756A3AA59}" dt="2024-06-21T15:36:35.529" v="0" actId="478"/>
          <ac:spMkLst>
            <pc:docMk/>
            <pc:sldMk cId="3935331238" sldId="268"/>
            <ac:spMk id="13" creationId="{F4565631-9F4F-C4D0-1CFB-0C52011139CC}"/>
          </ac:spMkLst>
        </pc:spChg>
        <pc:spChg chg="del">
          <ac:chgData name="Mireille Vankemmelbeke" userId="e2496c92-8ae2-4817-81db-1e2fdf7923b3" providerId="ADAL" clId="{4B5540E2-12A2-4CC7-9B89-4E6756A3AA59}" dt="2024-06-21T15:36:50.045" v="3" actId="478"/>
          <ac:spMkLst>
            <pc:docMk/>
            <pc:sldMk cId="3935331238" sldId="268"/>
            <ac:spMk id="15" creationId="{6FC8C258-8525-A2DF-0C57-7C5EB072650E}"/>
          </ac:spMkLst>
        </pc:spChg>
        <pc:spChg chg="del">
          <ac:chgData name="Mireille Vankemmelbeke" userId="e2496c92-8ae2-4817-81db-1e2fdf7923b3" providerId="ADAL" clId="{4B5540E2-12A2-4CC7-9B89-4E6756A3AA59}" dt="2024-06-21T15:36:35.529" v="0" actId="478"/>
          <ac:spMkLst>
            <pc:docMk/>
            <pc:sldMk cId="3935331238" sldId="268"/>
            <ac:spMk id="16" creationId="{3A6C0FD7-6959-1587-2E5D-AAEB3F8465DA}"/>
          </ac:spMkLst>
        </pc:spChg>
        <pc:spChg chg="mod">
          <ac:chgData name="Mireille Vankemmelbeke" userId="e2496c92-8ae2-4817-81db-1e2fdf7923b3" providerId="ADAL" clId="{4B5540E2-12A2-4CC7-9B89-4E6756A3AA59}" dt="2024-06-21T15:36:47.764" v="2" actId="1076"/>
          <ac:spMkLst>
            <pc:docMk/>
            <pc:sldMk cId="3935331238" sldId="268"/>
            <ac:spMk id="18" creationId="{F4E7CC6C-854B-6244-16A0-7FDF0F15E499}"/>
          </ac:spMkLst>
        </pc:spChg>
        <pc:spChg chg="mod">
          <ac:chgData name="Mireille Vankemmelbeke" userId="e2496c92-8ae2-4817-81db-1e2fdf7923b3" providerId="ADAL" clId="{4B5540E2-12A2-4CC7-9B89-4E6756A3AA59}" dt="2024-06-21T15:36:47.764" v="2" actId="1076"/>
          <ac:spMkLst>
            <pc:docMk/>
            <pc:sldMk cId="3935331238" sldId="268"/>
            <ac:spMk id="20" creationId="{647588B9-6635-78F5-91C7-12C820028590}"/>
          </ac:spMkLst>
        </pc:spChg>
        <pc:spChg chg="mod">
          <ac:chgData name="Mireille Vankemmelbeke" userId="e2496c92-8ae2-4817-81db-1e2fdf7923b3" providerId="ADAL" clId="{4B5540E2-12A2-4CC7-9B89-4E6756A3AA59}" dt="2024-06-21T15:36:47.764" v="2" actId="1076"/>
          <ac:spMkLst>
            <pc:docMk/>
            <pc:sldMk cId="3935331238" sldId="268"/>
            <ac:spMk id="21" creationId="{8BA43F7C-912C-8ECD-6D13-02611A596775}"/>
          </ac:spMkLst>
        </pc:spChg>
        <pc:spChg chg="del">
          <ac:chgData name="Mireille Vankemmelbeke" userId="e2496c92-8ae2-4817-81db-1e2fdf7923b3" providerId="ADAL" clId="{4B5540E2-12A2-4CC7-9B89-4E6756A3AA59}" dt="2024-06-21T15:36:41.952" v="1" actId="478"/>
          <ac:spMkLst>
            <pc:docMk/>
            <pc:sldMk cId="3935331238" sldId="268"/>
            <ac:spMk id="23" creationId="{1323D973-24A6-69E1-63BB-AAE450CCC9E6}"/>
          </ac:spMkLst>
        </pc:spChg>
        <pc:spChg chg="del">
          <ac:chgData name="Mireille Vankemmelbeke" userId="e2496c92-8ae2-4817-81db-1e2fdf7923b3" providerId="ADAL" clId="{4B5540E2-12A2-4CC7-9B89-4E6756A3AA59}" dt="2024-06-21T15:36:35.529" v="0" actId="478"/>
          <ac:spMkLst>
            <pc:docMk/>
            <pc:sldMk cId="3935331238" sldId="268"/>
            <ac:spMk id="27" creationId="{0E1505E9-4973-7FF0-A4E6-FB325AF9754F}"/>
          </ac:spMkLst>
        </pc:spChg>
        <pc:spChg chg="del">
          <ac:chgData name="Mireille Vankemmelbeke" userId="e2496c92-8ae2-4817-81db-1e2fdf7923b3" providerId="ADAL" clId="{4B5540E2-12A2-4CC7-9B89-4E6756A3AA59}" dt="2024-06-21T15:36:35.529" v="0" actId="478"/>
          <ac:spMkLst>
            <pc:docMk/>
            <pc:sldMk cId="3935331238" sldId="268"/>
            <ac:spMk id="28" creationId="{5A31E918-6C9F-EF42-0695-E0BDCB0A7C3D}"/>
          </ac:spMkLst>
        </pc:spChg>
        <pc:spChg chg="del">
          <ac:chgData name="Mireille Vankemmelbeke" userId="e2496c92-8ae2-4817-81db-1e2fdf7923b3" providerId="ADAL" clId="{4B5540E2-12A2-4CC7-9B89-4E6756A3AA59}" dt="2024-06-21T15:36:35.529" v="0" actId="478"/>
          <ac:spMkLst>
            <pc:docMk/>
            <pc:sldMk cId="3935331238" sldId="268"/>
            <ac:spMk id="38" creationId="{C7DDF822-B914-4A88-9466-5C023EC4895A}"/>
          </ac:spMkLst>
        </pc:spChg>
        <pc:grpChg chg="mod">
          <ac:chgData name="Mireille Vankemmelbeke" userId="e2496c92-8ae2-4817-81db-1e2fdf7923b3" providerId="ADAL" clId="{4B5540E2-12A2-4CC7-9B89-4E6756A3AA59}" dt="2024-06-21T15:36:47.764" v="2" actId="1076"/>
          <ac:grpSpMkLst>
            <pc:docMk/>
            <pc:sldMk cId="3935331238" sldId="268"/>
            <ac:grpSpMk id="4" creationId="{CA438E9F-47E1-3BF7-4DBF-311027FCC2F7}"/>
          </ac:grpSpMkLst>
        </pc:grpChg>
        <pc:grpChg chg="del">
          <ac:chgData name="Mireille Vankemmelbeke" userId="e2496c92-8ae2-4817-81db-1e2fdf7923b3" providerId="ADAL" clId="{4B5540E2-12A2-4CC7-9B89-4E6756A3AA59}" dt="2024-06-21T15:36:35.529" v="0" actId="478"/>
          <ac:grpSpMkLst>
            <pc:docMk/>
            <pc:sldMk cId="3935331238" sldId="268"/>
            <ac:grpSpMk id="26" creationId="{FCF721D8-5A65-D3C4-1D36-67958D25B49C}"/>
          </ac:grpSpMkLst>
        </pc:grpChg>
        <pc:grpChg chg="del">
          <ac:chgData name="Mireille Vankemmelbeke" userId="e2496c92-8ae2-4817-81db-1e2fdf7923b3" providerId="ADAL" clId="{4B5540E2-12A2-4CC7-9B89-4E6756A3AA59}" dt="2024-06-21T15:36:35.529" v="0" actId="478"/>
          <ac:grpSpMkLst>
            <pc:docMk/>
            <pc:sldMk cId="3935331238" sldId="268"/>
            <ac:grpSpMk id="35" creationId="{5D514B5C-2C50-A53F-809C-1892AF271196}"/>
          </ac:grpSpMkLst>
        </pc:grpChg>
        <pc:picChg chg="del">
          <ac:chgData name="Mireille Vankemmelbeke" userId="e2496c92-8ae2-4817-81db-1e2fdf7923b3" providerId="ADAL" clId="{4B5540E2-12A2-4CC7-9B89-4E6756A3AA59}" dt="2024-06-21T15:36:41.952" v="1" actId="478"/>
          <ac:picMkLst>
            <pc:docMk/>
            <pc:sldMk cId="3935331238" sldId="268"/>
            <ac:picMk id="10" creationId="{86DA2D0F-ED30-6908-6CA2-9BFDE4C80CA0}"/>
          </ac:picMkLst>
        </pc:picChg>
        <pc:picChg chg="mod">
          <ac:chgData name="Mireille Vankemmelbeke" userId="e2496c92-8ae2-4817-81db-1e2fdf7923b3" providerId="ADAL" clId="{4B5540E2-12A2-4CC7-9B89-4E6756A3AA59}" dt="2024-06-21T15:36:47.764" v="2" actId="1076"/>
          <ac:picMkLst>
            <pc:docMk/>
            <pc:sldMk cId="3935331238" sldId="268"/>
            <ac:picMk id="29" creationId="{9EF0A7CC-D44C-B781-66A4-D496E53F1767}"/>
          </ac:picMkLst>
        </pc:picChg>
        <pc:picChg chg="del">
          <ac:chgData name="Mireille Vankemmelbeke" userId="e2496c92-8ae2-4817-81db-1e2fdf7923b3" providerId="ADAL" clId="{4B5540E2-12A2-4CC7-9B89-4E6756A3AA59}" dt="2024-06-21T15:36:35.529" v="0" actId="478"/>
          <ac:picMkLst>
            <pc:docMk/>
            <pc:sldMk cId="3935331238" sldId="268"/>
            <ac:picMk id="30" creationId="{42508664-B0C7-213A-5AAF-AFE57EC6C254}"/>
          </ac:picMkLst>
        </pc:picChg>
        <pc:picChg chg="mod">
          <ac:chgData name="Mireille Vankemmelbeke" userId="e2496c92-8ae2-4817-81db-1e2fdf7923b3" providerId="ADAL" clId="{4B5540E2-12A2-4CC7-9B89-4E6756A3AA59}" dt="2024-06-21T15:36:47.764" v="2" actId="1076"/>
          <ac:picMkLst>
            <pc:docMk/>
            <pc:sldMk cId="3935331238" sldId="268"/>
            <ac:picMk id="32" creationId="{D71BB802-F8FA-B9F5-62FE-6DDA85DC0CC0}"/>
          </ac:picMkLst>
        </pc:picChg>
        <pc:picChg chg="del">
          <ac:chgData name="Mireille Vankemmelbeke" userId="e2496c92-8ae2-4817-81db-1e2fdf7923b3" providerId="ADAL" clId="{4B5540E2-12A2-4CC7-9B89-4E6756A3AA59}" dt="2024-06-21T15:36:50.045" v="3" actId="478"/>
          <ac:picMkLst>
            <pc:docMk/>
            <pc:sldMk cId="3935331238" sldId="268"/>
            <ac:picMk id="34" creationId="{D395F453-6B32-21CF-E7D4-65CAAE1691F0}"/>
          </ac:picMkLst>
        </pc:picChg>
        <pc:picChg chg="del">
          <ac:chgData name="Mireille Vankemmelbeke" userId="e2496c92-8ae2-4817-81db-1e2fdf7923b3" providerId="ADAL" clId="{4B5540E2-12A2-4CC7-9B89-4E6756A3AA59}" dt="2024-06-21T15:36:35.529" v="0" actId="478"/>
          <ac:picMkLst>
            <pc:docMk/>
            <pc:sldMk cId="3935331238" sldId="268"/>
            <ac:picMk id="37" creationId="{241969AE-1E1E-FCFD-3B20-ADCF726A6A95}"/>
          </ac:picMkLst>
        </pc:picChg>
        <pc:picChg chg="del">
          <ac:chgData name="Mireille Vankemmelbeke" userId="e2496c92-8ae2-4817-81db-1e2fdf7923b3" providerId="ADAL" clId="{4B5540E2-12A2-4CC7-9B89-4E6756A3AA59}" dt="2024-06-21T15:36:35.529" v="0" actId="478"/>
          <ac:picMkLst>
            <pc:docMk/>
            <pc:sldMk cId="3935331238" sldId="268"/>
            <ac:picMk id="39" creationId="{8AA96BB3-6D0F-13D6-28DB-C113A52F9100}"/>
          </ac:picMkLst>
        </pc:picChg>
      </pc:sldChg>
      <pc:sldChg chg="del">
        <pc:chgData name="Mireille Vankemmelbeke" userId="e2496c92-8ae2-4817-81db-1e2fdf7923b3" providerId="ADAL" clId="{4B5540E2-12A2-4CC7-9B89-4E6756A3AA59}" dt="2024-06-21T15:36:54.417" v="4" actId="47"/>
        <pc:sldMkLst>
          <pc:docMk/>
          <pc:sldMk cId="868960993" sldId="269"/>
        </pc:sldMkLst>
      </pc:sldChg>
      <pc:sldChg chg="del">
        <pc:chgData name="Mireille Vankemmelbeke" userId="e2496c92-8ae2-4817-81db-1e2fdf7923b3" providerId="ADAL" clId="{4B5540E2-12A2-4CC7-9B89-4E6756A3AA59}" dt="2024-06-21T15:36:55.472" v="5" actId="47"/>
        <pc:sldMkLst>
          <pc:docMk/>
          <pc:sldMk cId="2268793920" sldId="270"/>
        </pc:sldMkLst>
      </pc:sldChg>
    </pc:docChg>
  </pc:docChgLst>
  <pc:docChgLst>
    <pc:chgData name="Mireille Vankemmelbeke" userId="e2496c92-8ae2-4817-81db-1e2fdf7923b3" providerId="ADAL" clId="{B8A63B0A-0174-4028-ADAB-E0D408F850A6}"/>
    <pc:docChg chg="undo custSel modSld">
      <pc:chgData name="Mireille Vankemmelbeke" userId="e2496c92-8ae2-4817-81db-1e2fdf7923b3" providerId="ADAL" clId="{B8A63B0A-0174-4028-ADAB-E0D408F850A6}" dt="2024-08-01T08:25:48.399" v="37" actId="6549"/>
      <pc:docMkLst>
        <pc:docMk/>
      </pc:docMkLst>
      <pc:sldChg chg="modSp mod">
        <pc:chgData name="Mireille Vankemmelbeke" userId="e2496c92-8ae2-4817-81db-1e2fdf7923b3" providerId="ADAL" clId="{B8A63B0A-0174-4028-ADAB-E0D408F850A6}" dt="2024-08-01T08:25:48.399" v="37" actId="6549"/>
        <pc:sldMkLst>
          <pc:docMk/>
          <pc:sldMk cId="3935331238" sldId="268"/>
        </pc:sldMkLst>
        <pc:spChg chg="mod">
          <ac:chgData name="Mireille Vankemmelbeke" userId="e2496c92-8ae2-4817-81db-1e2fdf7923b3" providerId="ADAL" clId="{B8A63B0A-0174-4028-ADAB-E0D408F850A6}" dt="2024-08-01T08:25:48.399" v="37" actId="6549"/>
          <ac:spMkLst>
            <pc:docMk/>
            <pc:sldMk cId="3935331238" sldId="268"/>
            <ac:spMk id="9" creationId="{329F8FB0-E780-D480-8A95-4E9518BEA6E8}"/>
          </ac:spMkLst>
        </pc:spChg>
        <pc:spChg chg="mod">
          <ac:chgData name="Mireille Vankemmelbeke" userId="e2496c92-8ae2-4817-81db-1e2fdf7923b3" providerId="ADAL" clId="{B8A63B0A-0174-4028-ADAB-E0D408F850A6}" dt="2024-08-01T08:25:02.386" v="8" actId="113"/>
          <ac:spMkLst>
            <pc:docMk/>
            <pc:sldMk cId="3935331238" sldId="268"/>
            <ac:spMk id="18" creationId="{F4E7CC6C-854B-6244-16A0-7FDF0F15E499}"/>
          </ac:spMkLst>
        </pc:spChg>
        <pc:spChg chg="mod">
          <ac:chgData name="Mireille Vankemmelbeke" userId="e2496c92-8ae2-4817-81db-1e2fdf7923b3" providerId="ADAL" clId="{B8A63B0A-0174-4028-ADAB-E0D408F850A6}" dt="2024-08-01T08:25:02.386" v="8" actId="113"/>
          <ac:spMkLst>
            <pc:docMk/>
            <pc:sldMk cId="3935331238" sldId="268"/>
            <ac:spMk id="20" creationId="{647588B9-6635-78F5-91C7-12C820028590}"/>
          </ac:spMkLst>
        </pc:spChg>
        <pc:spChg chg="mod">
          <ac:chgData name="Mireille Vankemmelbeke" userId="e2496c92-8ae2-4817-81db-1e2fdf7923b3" providerId="ADAL" clId="{B8A63B0A-0174-4028-ADAB-E0D408F850A6}" dt="2024-08-01T08:25:02.386" v="8" actId="113"/>
          <ac:spMkLst>
            <pc:docMk/>
            <pc:sldMk cId="3935331238" sldId="268"/>
            <ac:spMk id="21" creationId="{8BA43F7C-912C-8ECD-6D13-02611A596775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07ED1A2-C795-4A89-BC5A-004D576CF3DF}" type="datetimeFigureOut">
              <a:rPr lang="en-GB" smtClean="0"/>
              <a:t>01/08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A34F97C-AF6A-4678-A188-E641391358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31473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01/08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40817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01/08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34315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01/08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97030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01/08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19088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01/08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63236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01/08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98543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01/08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87447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01/08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95993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01/08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70211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01/08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36878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01/08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984850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B2FAE3E-4C77-4744-B238-740C31CDFDF5}" type="datetimeFigureOut">
              <a:rPr lang="en-GB" smtClean="0"/>
              <a:t>01/08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56388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4.emf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1">
            <a:extLst>
              <a:ext uri="{FF2B5EF4-FFF2-40B4-BE49-F238E27FC236}">
                <a16:creationId xmlns:a16="http://schemas.microsoft.com/office/drawing/2014/main" id="{329F8FB0-E780-D480-8A95-4E9518BEA6E8}"/>
              </a:ext>
            </a:extLst>
          </p:cNvPr>
          <p:cNvSpPr txBox="1"/>
          <p:nvPr/>
        </p:nvSpPr>
        <p:spPr>
          <a:xfrm>
            <a:off x="0" y="1024832"/>
            <a:ext cx="6793992" cy="64633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GB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l Figure 3</a:t>
            </a:r>
            <a:r>
              <a:rPr lang="en-GB" sz="9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</a:t>
            </a:r>
            <a:r>
              <a:rPr lang="en-GB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</a:t>
            </a:r>
            <a:r>
              <a:rPr lang="en-GB" sz="9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Target-dependent killing by SC134-TCB. Lack of killing (LDH) or reduced cytotoxicity (flow-based) by the non-targeting B12-TCB on target positive DMS79. </a:t>
            </a:r>
            <a:r>
              <a:rPr lang="en-GB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</a:t>
            </a:r>
            <a:r>
              <a:rPr lang="en-GB" sz="9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Tumour cell killing by SC134-TCB on FucGM1 positive cell line DMS153 compared to absence of killing on the target negative cell line H146. </a:t>
            </a:r>
            <a:r>
              <a:rPr lang="en-GB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</a:t>
            </a:r>
            <a:r>
              <a:rPr lang="en-GB" sz="9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DMS79 cell killing by the control </a:t>
            </a:r>
            <a:r>
              <a:rPr lang="en-GB" sz="9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pCAM</a:t>
            </a:r>
            <a:r>
              <a:rPr lang="en-GB" sz="9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targeting TCB, catumaxomab.  Increased killing observed with higher E:T ratios.</a:t>
            </a:r>
          </a:p>
        </p:txBody>
      </p:sp>
      <p:sp>
        <p:nvSpPr>
          <p:cNvPr id="14" name="Title 1">
            <a:extLst>
              <a:ext uri="{FF2B5EF4-FFF2-40B4-BE49-F238E27FC236}">
                <a16:creationId xmlns:a16="http://schemas.microsoft.com/office/drawing/2014/main" id="{32A62937-3779-0616-05B7-500E83122552}"/>
              </a:ext>
            </a:extLst>
          </p:cNvPr>
          <p:cNvSpPr txBox="1">
            <a:spLocks/>
          </p:cNvSpPr>
          <p:nvPr/>
        </p:nvSpPr>
        <p:spPr>
          <a:xfrm>
            <a:off x="95251" y="359591"/>
            <a:ext cx="5604510" cy="42271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2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l Figures</a:t>
            </a:r>
            <a:endParaRPr lang="en-GB" sz="11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47588B9-6635-78F5-91C7-12C820028590}"/>
              </a:ext>
            </a:extLst>
          </p:cNvPr>
          <p:cNvSpPr txBox="1"/>
          <p:nvPr/>
        </p:nvSpPr>
        <p:spPr>
          <a:xfrm>
            <a:off x="2472065" y="1593566"/>
            <a:ext cx="3192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BA43F7C-912C-8ECD-6D13-02611A596775}"/>
              </a:ext>
            </a:extLst>
          </p:cNvPr>
          <p:cNvSpPr txBox="1"/>
          <p:nvPr/>
        </p:nvSpPr>
        <p:spPr>
          <a:xfrm>
            <a:off x="141108" y="1589756"/>
            <a:ext cx="2795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CA438E9F-47E1-3BF7-4DBF-311027FCC2F7}"/>
              </a:ext>
            </a:extLst>
          </p:cNvPr>
          <p:cNvGrpSpPr/>
          <p:nvPr/>
        </p:nvGrpSpPr>
        <p:grpSpPr>
          <a:xfrm>
            <a:off x="2676906" y="1732535"/>
            <a:ext cx="2008632" cy="1260000"/>
            <a:chOff x="3063240" y="7415785"/>
            <a:chExt cx="2008632" cy="1220542"/>
          </a:xfrm>
        </p:grpSpPr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id="{7D27516C-2E8F-4FED-9527-4B330351F00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5867" t="19354" r="11071" b="1935"/>
            <a:stretch/>
          </p:blipFill>
          <p:spPr>
            <a:xfrm>
              <a:off x="3063240" y="7415785"/>
              <a:ext cx="2008632" cy="1220542"/>
            </a:xfrm>
            <a:prstGeom prst="rect">
              <a:avLst/>
            </a:prstGeom>
          </p:spPr>
        </p:pic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7B6729B7-6564-B21B-082D-528EE847E96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r="32510" b="4524"/>
            <a:stretch/>
          </p:blipFill>
          <p:spPr>
            <a:xfrm>
              <a:off x="3359215" y="7487920"/>
              <a:ext cx="901378" cy="525780"/>
            </a:xfrm>
            <a:prstGeom prst="rect">
              <a:avLst/>
            </a:prstGeom>
          </p:spPr>
        </p:pic>
      </p:grpSp>
      <p:pic>
        <p:nvPicPr>
          <p:cNvPr id="32" name="Picture 31">
            <a:extLst>
              <a:ext uri="{FF2B5EF4-FFF2-40B4-BE49-F238E27FC236}">
                <a16:creationId xmlns:a16="http://schemas.microsoft.com/office/drawing/2014/main" id="{D71BB802-F8FA-B9F5-62FE-6DDA85DC0CC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7352" y="1755842"/>
            <a:ext cx="2178668" cy="1260000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F4E7CC6C-854B-6244-16A0-7FDF0F15E499}"/>
              </a:ext>
            </a:extLst>
          </p:cNvPr>
          <p:cNvSpPr txBox="1"/>
          <p:nvPr/>
        </p:nvSpPr>
        <p:spPr>
          <a:xfrm>
            <a:off x="4708535" y="1592296"/>
            <a:ext cx="3192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</a:t>
            </a:r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9EF0A7CC-D44C-B781-66A4-D496E53F1767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12395" r="3460" b="15034"/>
          <a:stretch/>
        </p:blipFill>
        <p:spPr>
          <a:xfrm>
            <a:off x="4796643" y="1786906"/>
            <a:ext cx="2498999" cy="12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353312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86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reille Vankemmelbeke</dc:creator>
  <cp:lastModifiedBy>Mireille Vankemmelbeke</cp:lastModifiedBy>
  <cp:revision>3</cp:revision>
  <dcterms:created xsi:type="dcterms:W3CDTF">2024-03-08T14:10:38Z</dcterms:created>
  <dcterms:modified xsi:type="dcterms:W3CDTF">2024-08-01T08:25:57Z</dcterms:modified>
</cp:coreProperties>
</file>